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551613" cy="925195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655B2-AFBE-4A87-A22D-A27CFB7AF1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589932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26520" y="5348880"/>
            <a:ext cx="589932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45828-D071-4214-AE6A-E3237F5FCC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34944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26520" y="534888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349440" y="534888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B5132-A9D6-4E1B-A131-92BF2E8406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321280" y="215892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316040" y="215892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26520" y="534888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321280" y="534888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316040" y="5348880"/>
            <a:ext cx="18993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E512F5-5F3A-410E-AEB2-92C3614A01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26520" y="2158920"/>
            <a:ext cx="5899320" cy="610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5F790-4C15-4F1B-80C2-675810D92A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589932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E89F1-43D2-4D1E-920B-D7EA43EBE4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287856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349440" y="2158920"/>
            <a:ext cx="287856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03105-CE03-4101-AE88-30F588094A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8E287-2C9F-477A-B4B1-E26A8B264E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6520" y="371520"/>
            <a:ext cx="5899320" cy="714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0B21F-B2DC-4367-9350-95943B1679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349440" y="2158920"/>
            <a:ext cx="287856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26520" y="534888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D3E5B-28D3-4476-A1FB-1313133D41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287856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34944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349440" y="534888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F97F5-CCE8-4E73-92A9-EF7035DEE7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2652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349440" y="2158920"/>
            <a:ext cx="287856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26520" y="5348880"/>
            <a:ext cx="5899320" cy="291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6E7C8-B28F-44D1-BCC8-459759C163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26520" y="371520"/>
            <a:ext cx="5899320" cy="154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26520" y="2158920"/>
            <a:ext cx="5899320" cy="610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26520" y="8426520"/>
            <a:ext cx="1530360" cy="642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38480" y="8426520"/>
            <a:ext cx="2076480" cy="642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695480" y="8426520"/>
            <a:ext cx="1530360" cy="642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069EAC-4185-4F37-B81C-208F32821E77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82520" y="1695600"/>
          <a:ext cx="4310280" cy="5270400"/>
        </p:xfrm>
        <a:graphic>
          <a:graphicData uri="http://schemas.openxmlformats.org/drawingml/2006/table">
            <a:tbl>
              <a:tblPr/>
              <a:tblGrid>
                <a:gridCol w="965520"/>
                <a:gridCol w="887400"/>
                <a:gridCol w="2457360"/>
              </a:tblGrid>
              <a:tr h="396720"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me of Ge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irec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cleotide seque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73680"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σ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β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γ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ε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ζ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η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14-3-3θ(τ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RhoGDI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β-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7480" rIns="87480" tIns="46440" bIns="4644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GAGCGAAACCTGCTCT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TGATGAGGGTGCTGTCTT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GCAGGCTGAGCGATATG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CAGGCTACAGGCCTTTT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CTGAATGAGCCACTGTCGA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GCGTGGAGTCCTTGTAGG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GTAGCAGGGATGGATG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TAGGATGCGTTGGTGG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GCAGGCTGAGCGATATG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GTTAAGGGCCAGACCCA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CAGCATTGAGCAGAAAACC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TGTGTCCAGCTCAGCTA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GAGCAGAAGACCGACAC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TCCTGCACTGTCTGATG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ATGACTGAAAAAGCCCC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TCATTCTGTCCACTCC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CCAGATCATGTTTGAGAC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바탕"/>
                        </a:rPr>
                        <a:t>5’-TTGAAGGTAGTTTCGTGGAT-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87480" marR="87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1028160" y="1446120"/>
            <a:ext cx="43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. Primer sequences used for RT-PCR analys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 Box 10"/>
          <p:cNvSpPr/>
          <p:nvPr/>
        </p:nvSpPr>
        <p:spPr>
          <a:xfrm>
            <a:off x="65880" y="65160"/>
            <a:ext cx="268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23T02:28:40Z</dcterms:created>
  <dc:creator>USER</dc:creator>
  <dc:description/>
  <dc:language>en-US</dc:language>
  <cp:lastModifiedBy>USER</cp:lastModifiedBy>
  <cp:lastPrinted>2012-11-13T00:23:34Z</cp:lastPrinted>
  <dcterms:modified xsi:type="dcterms:W3CDTF">2013-08-27T02:46:01Z</dcterms:modified>
  <cp:revision>620</cp:revision>
  <dc:subject/>
  <dc:title>슬라이드 1</dc:title>
</cp:coreProperties>
</file>